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65" r:id="rId2"/>
  </p:sldIdLst>
  <p:sldSz cx="9359900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DCF8"/>
    <a:srgbClr val="FF0000"/>
    <a:srgbClr val="156082"/>
    <a:srgbClr val="46B1E1"/>
    <a:srgbClr val="3B7D23"/>
    <a:srgbClr val="A6CAEC"/>
    <a:srgbClr val="61CBF4"/>
    <a:srgbClr val="C1E5F5"/>
    <a:srgbClr val="E59E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5" d="100"/>
          <a:sy n="55" d="100"/>
        </p:scale>
        <p:origin x="27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1993" y="1649770"/>
            <a:ext cx="7955915" cy="3509551"/>
          </a:xfrm>
        </p:spPr>
        <p:txBody>
          <a:bodyPr anchor="b"/>
          <a:lstStyle>
            <a:lvl1pPr algn="ctr">
              <a:defRPr sz="6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5294662"/>
            <a:ext cx="7019925" cy="2433817"/>
          </a:xfrm>
        </p:spPr>
        <p:txBody>
          <a:bodyPr/>
          <a:lstStyle>
            <a:lvl1pPr marL="0" indent="0" algn="ctr">
              <a:buNone/>
              <a:defRPr sz="2457"/>
            </a:lvl1pPr>
            <a:lvl2pPr marL="467990" indent="0" algn="ctr">
              <a:buNone/>
              <a:defRPr sz="2047"/>
            </a:lvl2pPr>
            <a:lvl3pPr marL="935980" indent="0" algn="ctr">
              <a:buNone/>
              <a:defRPr sz="1842"/>
            </a:lvl3pPr>
            <a:lvl4pPr marL="1403970" indent="0" algn="ctr">
              <a:buNone/>
              <a:defRPr sz="1638"/>
            </a:lvl4pPr>
            <a:lvl5pPr marL="1871960" indent="0" algn="ctr">
              <a:buNone/>
              <a:defRPr sz="1638"/>
            </a:lvl5pPr>
            <a:lvl6pPr marL="2339950" indent="0" algn="ctr">
              <a:buNone/>
              <a:defRPr sz="1638"/>
            </a:lvl6pPr>
            <a:lvl7pPr marL="2807940" indent="0" algn="ctr">
              <a:buNone/>
              <a:defRPr sz="1638"/>
            </a:lvl7pPr>
            <a:lvl8pPr marL="3275929" indent="0" algn="ctr">
              <a:buNone/>
              <a:defRPr sz="1638"/>
            </a:lvl8pPr>
            <a:lvl9pPr marL="3743919" indent="0" algn="ctr">
              <a:buNone/>
              <a:defRPr sz="163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31954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211207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536700"/>
            <a:ext cx="2018228" cy="85428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536700"/>
            <a:ext cx="5937687" cy="85428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52705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8262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9" y="2513159"/>
            <a:ext cx="8072914" cy="4193259"/>
          </a:xfrm>
        </p:spPr>
        <p:txBody>
          <a:bodyPr anchor="b"/>
          <a:lstStyle>
            <a:lvl1pPr>
              <a:defRPr sz="6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9" y="6746088"/>
            <a:ext cx="8072914" cy="2205136"/>
          </a:xfrm>
        </p:spPr>
        <p:txBody>
          <a:bodyPr/>
          <a:lstStyle>
            <a:lvl1pPr marL="0" indent="0">
              <a:buNone/>
              <a:defRPr sz="2457">
                <a:solidFill>
                  <a:schemeClr val="tx1">
                    <a:tint val="82000"/>
                  </a:schemeClr>
                </a:solidFill>
              </a:defRPr>
            </a:lvl1pPr>
            <a:lvl2pPr marL="467990" indent="0">
              <a:buNone/>
              <a:defRPr sz="2047">
                <a:solidFill>
                  <a:schemeClr val="tx1">
                    <a:tint val="82000"/>
                  </a:schemeClr>
                </a:solidFill>
              </a:defRPr>
            </a:lvl2pPr>
            <a:lvl3pPr marL="935980" indent="0">
              <a:buNone/>
              <a:defRPr sz="1842">
                <a:solidFill>
                  <a:schemeClr val="tx1">
                    <a:tint val="82000"/>
                  </a:schemeClr>
                </a:solidFill>
              </a:defRPr>
            </a:lvl3pPr>
            <a:lvl4pPr marL="140397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4pPr>
            <a:lvl5pPr marL="187196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5pPr>
            <a:lvl6pPr marL="233995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6pPr>
            <a:lvl7pPr marL="280794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7pPr>
            <a:lvl8pPr marL="3275929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8pPr>
            <a:lvl9pPr marL="3743919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16249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2683500"/>
            <a:ext cx="3977958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2683500"/>
            <a:ext cx="3977958" cy="63960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83213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536702"/>
            <a:ext cx="8072914" cy="1948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2471154"/>
            <a:ext cx="3959676" cy="1211074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3682228"/>
            <a:ext cx="3959676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50" y="2471154"/>
            <a:ext cx="3979177" cy="1211074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50" y="3682228"/>
            <a:ext cx="3979177" cy="54160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3788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20749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994775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672042"/>
            <a:ext cx="3018811" cy="2352146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1451426"/>
            <a:ext cx="4738449" cy="7163777"/>
          </a:xfrm>
        </p:spPr>
        <p:txBody>
          <a:bodyPr/>
          <a:lstStyle>
            <a:lvl1pPr>
              <a:defRPr sz="3276"/>
            </a:lvl1pPr>
            <a:lvl2pPr>
              <a:defRPr sz="2866"/>
            </a:lvl2pPr>
            <a:lvl3pPr>
              <a:defRPr sz="2457"/>
            </a:lvl3pPr>
            <a:lvl4pPr>
              <a:defRPr sz="2047"/>
            </a:lvl4pPr>
            <a:lvl5pPr>
              <a:defRPr sz="2047"/>
            </a:lvl5pPr>
            <a:lvl6pPr>
              <a:defRPr sz="2047"/>
            </a:lvl6pPr>
            <a:lvl7pPr>
              <a:defRPr sz="2047"/>
            </a:lvl7pPr>
            <a:lvl8pPr>
              <a:defRPr sz="2047"/>
            </a:lvl8pPr>
            <a:lvl9pPr>
              <a:defRPr sz="204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024188"/>
            <a:ext cx="3018811" cy="560268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52806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672042"/>
            <a:ext cx="3018811" cy="2352146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1451426"/>
            <a:ext cx="4738449" cy="7163777"/>
          </a:xfrm>
        </p:spPr>
        <p:txBody>
          <a:bodyPr anchor="t"/>
          <a:lstStyle>
            <a:lvl1pPr marL="0" indent="0">
              <a:buNone/>
              <a:defRPr sz="3276"/>
            </a:lvl1pPr>
            <a:lvl2pPr marL="467990" indent="0">
              <a:buNone/>
              <a:defRPr sz="2866"/>
            </a:lvl2pPr>
            <a:lvl3pPr marL="935980" indent="0">
              <a:buNone/>
              <a:defRPr sz="2457"/>
            </a:lvl3pPr>
            <a:lvl4pPr marL="1403970" indent="0">
              <a:buNone/>
              <a:defRPr sz="2047"/>
            </a:lvl4pPr>
            <a:lvl5pPr marL="1871960" indent="0">
              <a:buNone/>
              <a:defRPr sz="2047"/>
            </a:lvl5pPr>
            <a:lvl6pPr marL="2339950" indent="0">
              <a:buNone/>
              <a:defRPr sz="2047"/>
            </a:lvl6pPr>
            <a:lvl7pPr marL="2807940" indent="0">
              <a:buNone/>
              <a:defRPr sz="2047"/>
            </a:lvl7pPr>
            <a:lvl8pPr marL="3275929" indent="0">
              <a:buNone/>
              <a:defRPr sz="2047"/>
            </a:lvl8pPr>
            <a:lvl9pPr marL="3743919" indent="0">
              <a:buNone/>
              <a:defRPr sz="204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024188"/>
            <a:ext cx="3018811" cy="560268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82121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536702"/>
            <a:ext cx="8072914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2683500"/>
            <a:ext cx="8072914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9343248"/>
            <a:ext cx="2105978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4A44A5-AD74-4627-938C-AD983FB0F66D}" type="datetimeFigureOut">
              <a:rPr lang="fr-CH" smtClean="0"/>
              <a:t>18.12.2025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9343248"/>
            <a:ext cx="3158966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9343248"/>
            <a:ext cx="2105978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5D9B72-A1AD-4B9D-A2CC-2807BA9A21D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1771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935980" rtl="0" eaLnBrk="1" latinLnBrk="0" hangingPunct="1">
        <a:lnSpc>
          <a:spcPct val="90000"/>
        </a:lnSpc>
        <a:spcBef>
          <a:spcPct val="0"/>
        </a:spcBef>
        <a:buNone/>
        <a:defRPr sz="45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3995" indent="-233995" algn="l" defTabSz="935980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2866" kern="1200">
          <a:solidFill>
            <a:schemeClr val="tx1"/>
          </a:solidFill>
          <a:latin typeface="+mn-lt"/>
          <a:ea typeface="+mn-ea"/>
          <a:cs typeface="+mn-cs"/>
        </a:defRPr>
      </a:lvl1pPr>
      <a:lvl2pPr marL="70198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457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047" kern="1200">
          <a:solidFill>
            <a:schemeClr val="tx1"/>
          </a:solidFill>
          <a:latin typeface="+mn-lt"/>
          <a:ea typeface="+mn-ea"/>
          <a:cs typeface="+mn-cs"/>
        </a:defRPr>
      </a:lvl3pPr>
      <a:lvl4pPr marL="163796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210595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57394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304193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50992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97791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93598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3pPr>
      <a:lvl4pPr marL="140397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187196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33995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280794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27592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74391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318B48-A8AA-AC67-E194-98479F9F67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459C3AE4-495C-0C2E-0A43-5A8DE0CB7E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" t="2574" r="17189" b="3345"/>
          <a:stretch>
            <a:fillRect/>
          </a:stretch>
        </p:blipFill>
        <p:spPr>
          <a:xfrm>
            <a:off x="99511" y="262960"/>
            <a:ext cx="9209136" cy="679156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C00C8557-A4AC-EC63-47F1-706D6E7FA126}"/>
              </a:ext>
            </a:extLst>
          </p:cNvPr>
          <p:cNvSpPr txBox="1"/>
          <p:nvPr/>
        </p:nvSpPr>
        <p:spPr>
          <a:xfrm>
            <a:off x="406399" y="6928717"/>
            <a:ext cx="8640763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CH" sz="1600" b="1" dirty="0"/>
              <a:t>Figure S1: </a:t>
            </a:r>
            <a:r>
              <a:rPr lang="en-US" sz="1600" i="1" dirty="0"/>
              <a:t>Intercorrelations within and between domains of cognitive, physical and metabolic resilience.  </a:t>
            </a:r>
            <a:r>
              <a:rPr lang="en-US" sz="1600" dirty="0"/>
              <a:t>The network depicts linear relationships among variables characterizing cognitive resilience, metabolic capacity, and recovery in tactical athletes. Solid lines indicate positive correlations, whereas dashed lines represent negative correlations that pass a 5% false‑discovery‑rate threshold. Line thickness reflects the strength of association (absolute Pearson correlation coefficients, |r|). Nodes belonging to different functional domains (traits) are grouped within color‑coded areas: cognitive resilience (purple), metabolic resistance capacity—including muscle oxygenation, muscle perfusion, respiration, cardiac output, and oxygen uptake (shades of blue)—, physical performance and mechanical resistance (dark and light red), and epigenetic/genetic features (green). Note: Epigenetic regulation of </a:t>
            </a:r>
            <a:r>
              <a:rPr lang="en-US" sz="1600" i="1" dirty="0"/>
              <a:t>ACE</a:t>
            </a:r>
            <a:r>
              <a:rPr lang="en-US" sz="1600" dirty="0"/>
              <a:t> and </a:t>
            </a:r>
            <a:r>
              <a:rPr lang="en-US" sz="1600" i="1" dirty="0"/>
              <a:t>COMT</a:t>
            </a:r>
            <a:r>
              <a:rPr lang="en-US" sz="1600" dirty="0"/>
              <a:t> gene activity provides a mechanistic link between cognitive resilience and metabolic resistance capacity. For further details, please refer to the list of abbreviations and Table S1.</a:t>
            </a:r>
          </a:p>
        </p:txBody>
      </p:sp>
      <p:sp>
        <p:nvSpPr>
          <p:cNvPr id="31" name="Freihandform: Form 5">
            <a:extLst>
              <a:ext uri="{FF2B5EF4-FFF2-40B4-BE49-F238E27FC236}">
                <a16:creationId xmlns:a16="http://schemas.microsoft.com/office/drawing/2014/main" id="{E34F881A-0675-53E3-3119-12E7EB5B9078}"/>
              </a:ext>
            </a:extLst>
          </p:cNvPr>
          <p:cNvSpPr/>
          <p:nvPr/>
        </p:nvSpPr>
        <p:spPr>
          <a:xfrm rot="431986">
            <a:off x="5721750" y="314567"/>
            <a:ext cx="3448119" cy="4461575"/>
          </a:xfrm>
          <a:custGeom>
            <a:avLst/>
            <a:gdLst>
              <a:gd name="connsiteX0" fmla="*/ 1955396 w 2990410"/>
              <a:gd name="connsiteY0" fmla="*/ 241714 h 4681900"/>
              <a:gd name="connsiteX1" fmla="*/ 1307696 w 2990410"/>
              <a:gd name="connsiteY1" fmla="*/ 414 h 4681900"/>
              <a:gd name="connsiteX2" fmla="*/ 736196 w 2990410"/>
              <a:gd name="connsiteY2" fmla="*/ 292514 h 4681900"/>
              <a:gd name="connsiteX3" fmla="*/ 101196 w 2990410"/>
              <a:gd name="connsiteY3" fmla="*/ 1067214 h 4681900"/>
              <a:gd name="connsiteX4" fmla="*/ 37696 w 2990410"/>
              <a:gd name="connsiteY4" fmla="*/ 1880014 h 4681900"/>
              <a:gd name="connsiteX5" fmla="*/ 469496 w 2990410"/>
              <a:gd name="connsiteY5" fmla="*/ 2654714 h 4681900"/>
              <a:gd name="connsiteX6" fmla="*/ 1561696 w 2990410"/>
              <a:gd name="connsiteY6" fmla="*/ 4293014 h 4681900"/>
              <a:gd name="connsiteX7" fmla="*/ 2285596 w 2990410"/>
              <a:gd name="connsiteY7" fmla="*/ 4674014 h 4681900"/>
              <a:gd name="connsiteX8" fmla="*/ 2793596 w 2990410"/>
              <a:gd name="connsiteY8" fmla="*/ 4077114 h 4681900"/>
              <a:gd name="connsiteX9" fmla="*/ 2984096 w 2990410"/>
              <a:gd name="connsiteY9" fmla="*/ 2045114 h 4681900"/>
              <a:gd name="connsiteX10" fmla="*/ 2590396 w 2990410"/>
              <a:gd name="connsiteY10" fmla="*/ 762414 h 4681900"/>
              <a:gd name="connsiteX11" fmla="*/ 1955396 w 2990410"/>
              <a:gd name="connsiteY11" fmla="*/ 241714 h 46819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990410" h="4681900">
                <a:moveTo>
                  <a:pt x="1955396" y="241714"/>
                </a:moveTo>
                <a:cubicBezTo>
                  <a:pt x="1741613" y="114714"/>
                  <a:pt x="1510896" y="-8053"/>
                  <a:pt x="1307696" y="414"/>
                </a:cubicBezTo>
                <a:cubicBezTo>
                  <a:pt x="1104496" y="8881"/>
                  <a:pt x="937279" y="114714"/>
                  <a:pt x="736196" y="292514"/>
                </a:cubicBezTo>
                <a:cubicBezTo>
                  <a:pt x="535113" y="470314"/>
                  <a:pt x="217613" y="802631"/>
                  <a:pt x="101196" y="1067214"/>
                </a:cubicBezTo>
                <a:cubicBezTo>
                  <a:pt x="-15221" y="1331797"/>
                  <a:pt x="-23687" y="1615431"/>
                  <a:pt x="37696" y="1880014"/>
                </a:cubicBezTo>
                <a:cubicBezTo>
                  <a:pt x="99079" y="2144597"/>
                  <a:pt x="215496" y="2252547"/>
                  <a:pt x="469496" y="2654714"/>
                </a:cubicBezTo>
                <a:cubicBezTo>
                  <a:pt x="723496" y="3056881"/>
                  <a:pt x="1259013" y="3956464"/>
                  <a:pt x="1561696" y="4293014"/>
                </a:cubicBezTo>
                <a:cubicBezTo>
                  <a:pt x="1864379" y="4629564"/>
                  <a:pt x="2080279" y="4709997"/>
                  <a:pt x="2285596" y="4674014"/>
                </a:cubicBezTo>
                <a:cubicBezTo>
                  <a:pt x="2490913" y="4638031"/>
                  <a:pt x="2677179" y="4515264"/>
                  <a:pt x="2793596" y="4077114"/>
                </a:cubicBezTo>
                <a:cubicBezTo>
                  <a:pt x="2910013" y="3638964"/>
                  <a:pt x="3017963" y="2597564"/>
                  <a:pt x="2984096" y="2045114"/>
                </a:cubicBezTo>
                <a:cubicBezTo>
                  <a:pt x="2950229" y="1492664"/>
                  <a:pt x="2763963" y="1058747"/>
                  <a:pt x="2590396" y="762414"/>
                </a:cubicBezTo>
                <a:cubicBezTo>
                  <a:pt x="2416829" y="466081"/>
                  <a:pt x="2169179" y="368714"/>
                  <a:pt x="1955396" y="241714"/>
                </a:cubicBezTo>
                <a:close/>
              </a:path>
            </a:pathLst>
          </a:custGeom>
          <a:solidFill>
            <a:srgbClr val="E59EDD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sz="2511" dirty="0"/>
          </a:p>
        </p:txBody>
      </p:sp>
      <p:sp>
        <p:nvSpPr>
          <p:cNvPr id="32" name="Freihandform: Form 9">
            <a:extLst>
              <a:ext uri="{FF2B5EF4-FFF2-40B4-BE49-F238E27FC236}">
                <a16:creationId xmlns:a16="http://schemas.microsoft.com/office/drawing/2014/main" id="{9ED09D2E-DC26-2D3B-1C54-1CC9718B0737}"/>
              </a:ext>
            </a:extLst>
          </p:cNvPr>
          <p:cNvSpPr/>
          <p:nvPr/>
        </p:nvSpPr>
        <p:spPr>
          <a:xfrm>
            <a:off x="4516014" y="1097379"/>
            <a:ext cx="2429462" cy="3245950"/>
          </a:xfrm>
          <a:custGeom>
            <a:avLst/>
            <a:gdLst>
              <a:gd name="connsiteX0" fmla="*/ 1024969 w 2106972"/>
              <a:gd name="connsiteY0" fmla="*/ 109225 h 3746868"/>
              <a:gd name="connsiteX1" fmla="*/ 1266269 w 2106972"/>
              <a:gd name="connsiteY1" fmla="*/ 1544325 h 3746868"/>
              <a:gd name="connsiteX2" fmla="*/ 2104469 w 2106972"/>
              <a:gd name="connsiteY2" fmla="*/ 3360425 h 3746868"/>
              <a:gd name="connsiteX3" fmla="*/ 1507569 w 2106972"/>
              <a:gd name="connsiteY3" fmla="*/ 3741425 h 3746868"/>
              <a:gd name="connsiteX4" fmla="*/ 1012269 w 2106972"/>
              <a:gd name="connsiteY4" fmla="*/ 3220725 h 3746868"/>
              <a:gd name="connsiteX5" fmla="*/ 440769 w 2106972"/>
              <a:gd name="connsiteY5" fmla="*/ 1722125 h 3746868"/>
              <a:gd name="connsiteX6" fmla="*/ 682069 w 2106972"/>
              <a:gd name="connsiteY6" fmla="*/ 972825 h 3746868"/>
              <a:gd name="connsiteX7" fmla="*/ 301069 w 2106972"/>
              <a:gd name="connsiteY7" fmla="*/ 604525 h 3746868"/>
              <a:gd name="connsiteX8" fmla="*/ 8969 w 2106972"/>
              <a:gd name="connsiteY8" fmla="*/ 414025 h 3746868"/>
              <a:gd name="connsiteX9" fmla="*/ 161369 w 2106972"/>
              <a:gd name="connsiteY9" fmla="*/ 134625 h 3746868"/>
              <a:gd name="connsiteX10" fmla="*/ 1024969 w 2106972"/>
              <a:gd name="connsiteY10" fmla="*/ 109225 h 37468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2106972" h="3746868">
                <a:moveTo>
                  <a:pt x="1024969" y="109225"/>
                </a:moveTo>
                <a:cubicBezTo>
                  <a:pt x="1209119" y="344175"/>
                  <a:pt x="1086352" y="1002458"/>
                  <a:pt x="1266269" y="1544325"/>
                </a:cubicBezTo>
                <a:cubicBezTo>
                  <a:pt x="1446186" y="2086192"/>
                  <a:pt x="2064252" y="2994242"/>
                  <a:pt x="2104469" y="3360425"/>
                </a:cubicBezTo>
                <a:cubicBezTo>
                  <a:pt x="2144686" y="3726608"/>
                  <a:pt x="1689602" y="3764708"/>
                  <a:pt x="1507569" y="3741425"/>
                </a:cubicBezTo>
                <a:cubicBezTo>
                  <a:pt x="1325536" y="3718142"/>
                  <a:pt x="1190069" y="3557275"/>
                  <a:pt x="1012269" y="3220725"/>
                </a:cubicBezTo>
                <a:cubicBezTo>
                  <a:pt x="834469" y="2884175"/>
                  <a:pt x="495802" y="2096775"/>
                  <a:pt x="440769" y="1722125"/>
                </a:cubicBezTo>
                <a:cubicBezTo>
                  <a:pt x="385736" y="1347475"/>
                  <a:pt x="705352" y="1159092"/>
                  <a:pt x="682069" y="972825"/>
                </a:cubicBezTo>
                <a:cubicBezTo>
                  <a:pt x="658786" y="786558"/>
                  <a:pt x="413252" y="697658"/>
                  <a:pt x="301069" y="604525"/>
                </a:cubicBezTo>
                <a:cubicBezTo>
                  <a:pt x="188886" y="511392"/>
                  <a:pt x="32252" y="492342"/>
                  <a:pt x="8969" y="414025"/>
                </a:cubicBezTo>
                <a:cubicBezTo>
                  <a:pt x="-14314" y="335708"/>
                  <a:pt x="-1614" y="185425"/>
                  <a:pt x="161369" y="134625"/>
                </a:cubicBezTo>
                <a:cubicBezTo>
                  <a:pt x="324352" y="83825"/>
                  <a:pt x="840819" y="-125725"/>
                  <a:pt x="1024969" y="109225"/>
                </a:cubicBezTo>
                <a:close/>
              </a:path>
            </a:pathLst>
          </a:custGeom>
          <a:solidFill>
            <a:srgbClr val="3B7D23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sz="2511" dirty="0"/>
          </a:p>
        </p:txBody>
      </p:sp>
      <p:sp>
        <p:nvSpPr>
          <p:cNvPr id="33" name="Freihandform: Form 10">
            <a:extLst>
              <a:ext uri="{FF2B5EF4-FFF2-40B4-BE49-F238E27FC236}">
                <a16:creationId xmlns:a16="http://schemas.microsoft.com/office/drawing/2014/main" id="{FC1BEAB4-3524-AB26-1085-DCF5C5B267B0}"/>
              </a:ext>
            </a:extLst>
          </p:cNvPr>
          <p:cNvSpPr/>
          <p:nvPr/>
        </p:nvSpPr>
        <p:spPr>
          <a:xfrm>
            <a:off x="4807710" y="4710223"/>
            <a:ext cx="2182505" cy="1186370"/>
          </a:xfrm>
          <a:custGeom>
            <a:avLst/>
            <a:gdLst>
              <a:gd name="connsiteX0" fmla="*/ 1182575 w 2771244"/>
              <a:gd name="connsiteY0" fmla="*/ 52548 h 1045531"/>
              <a:gd name="connsiteX1" fmla="*/ 2579575 w 2771244"/>
              <a:gd name="connsiteY1" fmla="*/ 52548 h 1045531"/>
              <a:gd name="connsiteX2" fmla="*/ 2706575 w 2771244"/>
              <a:gd name="connsiteY2" fmla="*/ 598648 h 1045531"/>
              <a:gd name="connsiteX3" fmla="*/ 2084275 w 2771244"/>
              <a:gd name="connsiteY3" fmla="*/ 992348 h 1045531"/>
              <a:gd name="connsiteX4" fmla="*/ 103075 w 2771244"/>
              <a:gd name="connsiteY4" fmla="*/ 954248 h 1045531"/>
              <a:gd name="connsiteX5" fmla="*/ 369775 w 2771244"/>
              <a:gd name="connsiteY5" fmla="*/ 192248 h 1045531"/>
              <a:gd name="connsiteX6" fmla="*/ 1131775 w 2771244"/>
              <a:gd name="connsiteY6" fmla="*/ 39848 h 10455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771244" h="1045531">
                <a:moveTo>
                  <a:pt x="1182575" y="52548"/>
                </a:moveTo>
                <a:cubicBezTo>
                  <a:pt x="1754075" y="7039"/>
                  <a:pt x="2325575" y="-38469"/>
                  <a:pt x="2579575" y="52548"/>
                </a:cubicBezTo>
                <a:cubicBezTo>
                  <a:pt x="2833575" y="143565"/>
                  <a:pt x="2789125" y="442015"/>
                  <a:pt x="2706575" y="598648"/>
                </a:cubicBezTo>
                <a:cubicBezTo>
                  <a:pt x="2624025" y="755281"/>
                  <a:pt x="2518191" y="933081"/>
                  <a:pt x="2084275" y="992348"/>
                </a:cubicBezTo>
                <a:cubicBezTo>
                  <a:pt x="1650359" y="1051615"/>
                  <a:pt x="388825" y="1087598"/>
                  <a:pt x="103075" y="954248"/>
                </a:cubicBezTo>
                <a:cubicBezTo>
                  <a:pt x="-182675" y="820898"/>
                  <a:pt x="198325" y="344648"/>
                  <a:pt x="369775" y="192248"/>
                </a:cubicBezTo>
                <a:cubicBezTo>
                  <a:pt x="541225" y="39848"/>
                  <a:pt x="836500" y="39848"/>
                  <a:pt x="1131775" y="39848"/>
                </a:cubicBezTo>
              </a:path>
            </a:pathLst>
          </a:custGeom>
          <a:solidFill>
            <a:srgbClr val="46B1E1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sz="2511"/>
          </a:p>
        </p:txBody>
      </p:sp>
      <p:sp>
        <p:nvSpPr>
          <p:cNvPr id="34" name="Freihandform: Form 8">
            <a:extLst>
              <a:ext uri="{FF2B5EF4-FFF2-40B4-BE49-F238E27FC236}">
                <a16:creationId xmlns:a16="http://schemas.microsoft.com/office/drawing/2014/main" id="{798C7E90-B64F-5312-901D-DFF2EEA35366}"/>
              </a:ext>
            </a:extLst>
          </p:cNvPr>
          <p:cNvSpPr/>
          <p:nvPr/>
        </p:nvSpPr>
        <p:spPr>
          <a:xfrm>
            <a:off x="964040" y="5501151"/>
            <a:ext cx="2220963" cy="1384383"/>
          </a:xfrm>
          <a:custGeom>
            <a:avLst/>
            <a:gdLst>
              <a:gd name="connsiteX0" fmla="*/ 2082850 w 2563704"/>
              <a:gd name="connsiteY0" fmla="*/ 1427347 h 1452747"/>
              <a:gd name="connsiteX1" fmla="*/ 2451150 w 2563704"/>
              <a:gd name="connsiteY1" fmla="*/ 1376547 h 1452747"/>
              <a:gd name="connsiteX2" fmla="*/ 2540050 w 2563704"/>
              <a:gd name="connsiteY2" fmla="*/ 982847 h 1452747"/>
              <a:gd name="connsiteX3" fmla="*/ 2070150 w 2563704"/>
              <a:gd name="connsiteY3" fmla="*/ 538347 h 1452747"/>
              <a:gd name="connsiteX4" fmla="*/ 1676450 w 2563704"/>
              <a:gd name="connsiteY4" fmla="*/ 17647 h 1452747"/>
              <a:gd name="connsiteX5" fmla="*/ 863650 w 2563704"/>
              <a:gd name="connsiteY5" fmla="*/ 220847 h 1452747"/>
              <a:gd name="connsiteX6" fmla="*/ 50 w 2563704"/>
              <a:gd name="connsiteY6" fmla="*/ 1160647 h 1452747"/>
              <a:gd name="connsiteX7" fmla="*/ 901750 w 2563704"/>
              <a:gd name="connsiteY7" fmla="*/ 1401947 h 1452747"/>
              <a:gd name="connsiteX8" fmla="*/ 2019350 w 2563704"/>
              <a:gd name="connsiteY8" fmla="*/ 1452747 h 14527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63704" h="1452747">
                <a:moveTo>
                  <a:pt x="2082850" y="1427347"/>
                </a:moveTo>
                <a:cubicBezTo>
                  <a:pt x="2228900" y="1438988"/>
                  <a:pt x="2374950" y="1450630"/>
                  <a:pt x="2451150" y="1376547"/>
                </a:cubicBezTo>
                <a:cubicBezTo>
                  <a:pt x="2527350" y="1302464"/>
                  <a:pt x="2603550" y="1122547"/>
                  <a:pt x="2540050" y="982847"/>
                </a:cubicBezTo>
                <a:cubicBezTo>
                  <a:pt x="2476550" y="843147"/>
                  <a:pt x="2214083" y="699214"/>
                  <a:pt x="2070150" y="538347"/>
                </a:cubicBezTo>
                <a:cubicBezTo>
                  <a:pt x="1926217" y="377480"/>
                  <a:pt x="1877533" y="70564"/>
                  <a:pt x="1676450" y="17647"/>
                </a:cubicBezTo>
                <a:cubicBezTo>
                  <a:pt x="1475367" y="-35270"/>
                  <a:pt x="1143050" y="30347"/>
                  <a:pt x="863650" y="220847"/>
                </a:cubicBezTo>
                <a:cubicBezTo>
                  <a:pt x="584250" y="411347"/>
                  <a:pt x="-6300" y="963797"/>
                  <a:pt x="50" y="1160647"/>
                </a:cubicBezTo>
                <a:cubicBezTo>
                  <a:pt x="6400" y="1357497"/>
                  <a:pt x="565200" y="1353264"/>
                  <a:pt x="901750" y="1401947"/>
                </a:cubicBezTo>
                <a:cubicBezTo>
                  <a:pt x="1238300" y="1450630"/>
                  <a:pt x="1628825" y="1451688"/>
                  <a:pt x="2019350" y="1452747"/>
                </a:cubicBezTo>
              </a:path>
            </a:pathLst>
          </a:custGeom>
          <a:solidFill>
            <a:srgbClr val="A6CAEC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sz="2511"/>
          </a:p>
        </p:txBody>
      </p:sp>
      <p:sp>
        <p:nvSpPr>
          <p:cNvPr id="36" name="Freihandform: Form 11">
            <a:extLst>
              <a:ext uri="{FF2B5EF4-FFF2-40B4-BE49-F238E27FC236}">
                <a16:creationId xmlns:a16="http://schemas.microsoft.com/office/drawing/2014/main" id="{08BADAAB-B8DE-5971-BB93-9D989E3F262E}"/>
              </a:ext>
            </a:extLst>
          </p:cNvPr>
          <p:cNvSpPr/>
          <p:nvPr/>
        </p:nvSpPr>
        <p:spPr>
          <a:xfrm>
            <a:off x="323966" y="4438465"/>
            <a:ext cx="2040147" cy="1354130"/>
          </a:xfrm>
          <a:custGeom>
            <a:avLst/>
            <a:gdLst>
              <a:gd name="connsiteX0" fmla="*/ 1393676 w 1946269"/>
              <a:gd name="connsiteY0" fmla="*/ 2636 h 1291819"/>
              <a:gd name="connsiteX1" fmla="*/ 730736 w 1946269"/>
              <a:gd name="connsiteY1" fmla="*/ 101696 h 1291819"/>
              <a:gd name="connsiteX2" fmla="*/ 6836 w 1946269"/>
              <a:gd name="connsiteY2" fmla="*/ 825596 h 1291819"/>
              <a:gd name="connsiteX3" fmla="*/ 410696 w 1946269"/>
              <a:gd name="connsiteY3" fmla="*/ 1290416 h 1291819"/>
              <a:gd name="connsiteX4" fmla="*/ 1126976 w 1946269"/>
              <a:gd name="connsiteY4" fmla="*/ 947516 h 1291819"/>
              <a:gd name="connsiteX5" fmla="*/ 1911836 w 1946269"/>
              <a:gd name="connsiteY5" fmla="*/ 337916 h 1291819"/>
              <a:gd name="connsiteX6" fmla="*/ 1767056 w 1946269"/>
              <a:gd name="connsiteY6" fmla="*/ 55976 h 1291819"/>
              <a:gd name="connsiteX7" fmla="*/ 1393676 w 1946269"/>
              <a:gd name="connsiteY7" fmla="*/ 2636 h 12918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946269" h="1291819">
                <a:moveTo>
                  <a:pt x="1393676" y="2636"/>
                </a:moveTo>
                <a:cubicBezTo>
                  <a:pt x="1220956" y="10256"/>
                  <a:pt x="961876" y="-35464"/>
                  <a:pt x="730736" y="101696"/>
                </a:cubicBezTo>
                <a:cubicBezTo>
                  <a:pt x="499596" y="238856"/>
                  <a:pt x="60176" y="627476"/>
                  <a:pt x="6836" y="825596"/>
                </a:cubicBezTo>
                <a:cubicBezTo>
                  <a:pt x="-46504" y="1023716"/>
                  <a:pt x="224006" y="1270096"/>
                  <a:pt x="410696" y="1290416"/>
                </a:cubicBezTo>
                <a:cubicBezTo>
                  <a:pt x="597386" y="1310736"/>
                  <a:pt x="876786" y="1106266"/>
                  <a:pt x="1126976" y="947516"/>
                </a:cubicBezTo>
                <a:cubicBezTo>
                  <a:pt x="1377166" y="788766"/>
                  <a:pt x="1805156" y="486506"/>
                  <a:pt x="1911836" y="337916"/>
                </a:cubicBezTo>
                <a:cubicBezTo>
                  <a:pt x="2018516" y="189326"/>
                  <a:pt x="1850876" y="110586"/>
                  <a:pt x="1767056" y="55976"/>
                </a:cubicBezTo>
                <a:cubicBezTo>
                  <a:pt x="1683236" y="1366"/>
                  <a:pt x="1566396" y="-4984"/>
                  <a:pt x="1393676" y="2636"/>
                </a:cubicBezTo>
                <a:close/>
              </a:path>
            </a:pathLst>
          </a:custGeom>
          <a:solidFill>
            <a:srgbClr val="156082">
              <a:alpha val="4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 sz="2511"/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06CB1135-2B99-C141-D8EC-5FFF3E6D0141}"/>
              </a:ext>
            </a:extLst>
          </p:cNvPr>
          <p:cNvSpPr/>
          <p:nvPr/>
        </p:nvSpPr>
        <p:spPr>
          <a:xfrm>
            <a:off x="110145" y="79761"/>
            <a:ext cx="4908424" cy="3978918"/>
          </a:xfrm>
          <a:custGeom>
            <a:avLst/>
            <a:gdLst>
              <a:gd name="csX0" fmla="*/ 3870117 w 4978115"/>
              <a:gd name="csY0" fmla="*/ 367902 h 3978918"/>
              <a:gd name="csX1" fmla="*/ 2422317 w 4978115"/>
              <a:gd name="csY1" fmla="*/ 17382 h 3978918"/>
              <a:gd name="csX2" fmla="*/ 989757 w 4978115"/>
              <a:gd name="csY2" fmla="*/ 855582 h 3978918"/>
              <a:gd name="csX3" fmla="*/ 349677 w 4978115"/>
              <a:gd name="csY3" fmla="*/ 2059542 h 3978918"/>
              <a:gd name="csX4" fmla="*/ 44877 w 4978115"/>
              <a:gd name="csY4" fmla="*/ 3827382 h 3978918"/>
              <a:gd name="csX5" fmla="*/ 1309797 w 4978115"/>
              <a:gd name="csY5" fmla="*/ 3842622 h 3978918"/>
              <a:gd name="csX6" fmla="*/ 2056557 w 4978115"/>
              <a:gd name="csY6" fmla="*/ 3461622 h 3978918"/>
              <a:gd name="csX7" fmla="*/ 4266357 w 4978115"/>
              <a:gd name="csY7" fmla="*/ 3370182 h 3978918"/>
              <a:gd name="csX8" fmla="*/ 4967397 w 4978115"/>
              <a:gd name="csY8" fmla="*/ 2775822 h 3978918"/>
              <a:gd name="csX9" fmla="*/ 4632117 w 4978115"/>
              <a:gd name="csY9" fmla="*/ 1297542 h 3978918"/>
              <a:gd name="csX10" fmla="*/ 3870117 w 4978115"/>
              <a:gd name="csY10" fmla="*/ 367902 h 3978918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  <a:cxn ang="0">
                <a:pos x="csX6" y="csY6"/>
              </a:cxn>
              <a:cxn ang="0">
                <a:pos x="csX7" y="csY7"/>
              </a:cxn>
              <a:cxn ang="0">
                <a:pos x="csX8" y="csY8"/>
              </a:cxn>
              <a:cxn ang="0">
                <a:pos x="csX9" y="csY9"/>
              </a:cxn>
              <a:cxn ang="0">
                <a:pos x="csX10" y="csY10"/>
              </a:cxn>
            </a:cxnLst>
            <a:rect l="l" t="t" r="r" b="b"/>
            <a:pathLst>
              <a:path w="4978115" h="3978918">
                <a:moveTo>
                  <a:pt x="3870117" y="367902"/>
                </a:moveTo>
                <a:cubicBezTo>
                  <a:pt x="3501817" y="154542"/>
                  <a:pt x="2902377" y="-63898"/>
                  <a:pt x="2422317" y="17382"/>
                </a:cubicBezTo>
                <a:cubicBezTo>
                  <a:pt x="1942257" y="98662"/>
                  <a:pt x="1335197" y="515222"/>
                  <a:pt x="989757" y="855582"/>
                </a:cubicBezTo>
                <a:cubicBezTo>
                  <a:pt x="644317" y="1195942"/>
                  <a:pt x="507157" y="1564242"/>
                  <a:pt x="349677" y="2059542"/>
                </a:cubicBezTo>
                <a:cubicBezTo>
                  <a:pt x="192197" y="2554842"/>
                  <a:pt x="-115143" y="3530202"/>
                  <a:pt x="44877" y="3827382"/>
                </a:cubicBezTo>
                <a:cubicBezTo>
                  <a:pt x="204897" y="4124562"/>
                  <a:pt x="974517" y="3903582"/>
                  <a:pt x="1309797" y="3842622"/>
                </a:cubicBezTo>
                <a:cubicBezTo>
                  <a:pt x="1645077" y="3781662"/>
                  <a:pt x="1563797" y="3540362"/>
                  <a:pt x="2056557" y="3461622"/>
                </a:cubicBezTo>
                <a:cubicBezTo>
                  <a:pt x="2549317" y="3382882"/>
                  <a:pt x="3781217" y="3484482"/>
                  <a:pt x="4266357" y="3370182"/>
                </a:cubicBezTo>
                <a:cubicBezTo>
                  <a:pt x="4751497" y="3255882"/>
                  <a:pt x="4906437" y="3121262"/>
                  <a:pt x="4967397" y="2775822"/>
                </a:cubicBezTo>
                <a:cubicBezTo>
                  <a:pt x="5028357" y="2430382"/>
                  <a:pt x="4817537" y="1696322"/>
                  <a:pt x="4632117" y="1297542"/>
                </a:cubicBezTo>
                <a:cubicBezTo>
                  <a:pt x="4446697" y="898762"/>
                  <a:pt x="4238417" y="581262"/>
                  <a:pt x="3870117" y="367902"/>
                </a:cubicBezTo>
                <a:close/>
              </a:path>
            </a:pathLst>
          </a:custGeom>
          <a:solidFill>
            <a:srgbClr val="FF0000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BBC50E6E-8992-089F-E4E6-E2493D3C0E37}"/>
              </a:ext>
            </a:extLst>
          </p:cNvPr>
          <p:cNvSpPr/>
          <p:nvPr/>
        </p:nvSpPr>
        <p:spPr>
          <a:xfrm>
            <a:off x="1807535" y="3423682"/>
            <a:ext cx="3062660" cy="2679404"/>
          </a:xfrm>
          <a:custGeom>
            <a:avLst/>
            <a:gdLst>
              <a:gd name="connsiteX0" fmla="*/ 3264195 w 3264195"/>
              <a:gd name="connsiteY0" fmla="*/ 1201479 h 2626242"/>
              <a:gd name="connsiteX1" fmla="*/ 3242930 w 3264195"/>
              <a:gd name="connsiteY1" fmla="*/ 723014 h 2626242"/>
              <a:gd name="connsiteX2" fmla="*/ 3094074 w 3264195"/>
              <a:gd name="connsiteY2" fmla="*/ 106325 h 2626242"/>
              <a:gd name="connsiteX3" fmla="*/ 3040912 w 3264195"/>
              <a:gd name="connsiteY3" fmla="*/ 31898 h 2626242"/>
              <a:gd name="connsiteX4" fmla="*/ 2923954 w 3264195"/>
              <a:gd name="connsiteY4" fmla="*/ 0 h 2626242"/>
              <a:gd name="connsiteX5" fmla="*/ 2764465 w 3264195"/>
              <a:gd name="connsiteY5" fmla="*/ 21265 h 2626242"/>
              <a:gd name="connsiteX6" fmla="*/ 2190307 w 3264195"/>
              <a:gd name="connsiteY6" fmla="*/ 74428 h 2626242"/>
              <a:gd name="connsiteX7" fmla="*/ 1765005 w 3264195"/>
              <a:gd name="connsiteY7" fmla="*/ 74428 h 2626242"/>
              <a:gd name="connsiteX8" fmla="*/ 935665 w 3264195"/>
              <a:gd name="connsiteY8" fmla="*/ 85060 h 2626242"/>
              <a:gd name="connsiteX9" fmla="*/ 574158 w 3264195"/>
              <a:gd name="connsiteY9" fmla="*/ 85060 h 2626242"/>
              <a:gd name="connsiteX10" fmla="*/ 350874 w 3264195"/>
              <a:gd name="connsiteY10" fmla="*/ 85060 h 2626242"/>
              <a:gd name="connsiteX11" fmla="*/ 212651 w 3264195"/>
              <a:gd name="connsiteY11" fmla="*/ 127591 h 2626242"/>
              <a:gd name="connsiteX12" fmla="*/ 127591 w 3264195"/>
              <a:gd name="connsiteY12" fmla="*/ 180753 h 2626242"/>
              <a:gd name="connsiteX13" fmla="*/ 53163 w 3264195"/>
              <a:gd name="connsiteY13" fmla="*/ 297711 h 2626242"/>
              <a:gd name="connsiteX14" fmla="*/ 0 w 3264195"/>
              <a:gd name="connsiteY14" fmla="*/ 510363 h 2626242"/>
              <a:gd name="connsiteX15" fmla="*/ 21265 w 3264195"/>
              <a:gd name="connsiteY15" fmla="*/ 723014 h 2626242"/>
              <a:gd name="connsiteX16" fmla="*/ 127591 w 3264195"/>
              <a:gd name="connsiteY16" fmla="*/ 999460 h 2626242"/>
              <a:gd name="connsiteX17" fmla="*/ 669851 w 3264195"/>
              <a:gd name="connsiteY17" fmla="*/ 1244009 h 2626242"/>
              <a:gd name="connsiteX18" fmla="*/ 797442 w 3264195"/>
              <a:gd name="connsiteY18" fmla="*/ 1360967 h 2626242"/>
              <a:gd name="connsiteX19" fmla="*/ 893135 w 3264195"/>
              <a:gd name="connsiteY19" fmla="*/ 1488558 h 2626242"/>
              <a:gd name="connsiteX20" fmla="*/ 914400 w 3264195"/>
              <a:gd name="connsiteY20" fmla="*/ 1775637 h 2626242"/>
              <a:gd name="connsiteX21" fmla="*/ 946298 w 3264195"/>
              <a:gd name="connsiteY21" fmla="*/ 2222205 h 2626242"/>
              <a:gd name="connsiteX22" fmla="*/ 988828 w 3264195"/>
              <a:gd name="connsiteY22" fmla="*/ 2445488 h 2626242"/>
              <a:gd name="connsiteX23" fmla="*/ 1105786 w 3264195"/>
              <a:gd name="connsiteY23" fmla="*/ 2488018 h 2626242"/>
              <a:gd name="connsiteX24" fmla="*/ 1371600 w 3264195"/>
              <a:gd name="connsiteY24" fmla="*/ 2562446 h 2626242"/>
              <a:gd name="connsiteX25" fmla="*/ 1935126 w 3264195"/>
              <a:gd name="connsiteY25" fmla="*/ 2615609 h 2626242"/>
              <a:gd name="connsiteX26" fmla="*/ 2477386 w 3264195"/>
              <a:gd name="connsiteY26" fmla="*/ 2626242 h 2626242"/>
              <a:gd name="connsiteX27" fmla="*/ 2955851 w 3264195"/>
              <a:gd name="connsiteY27" fmla="*/ 2615609 h 2626242"/>
              <a:gd name="connsiteX28" fmla="*/ 3083442 w 3264195"/>
              <a:gd name="connsiteY28" fmla="*/ 2541181 h 2626242"/>
              <a:gd name="connsiteX29" fmla="*/ 3211033 w 3264195"/>
              <a:gd name="connsiteY29" fmla="*/ 2360428 h 2626242"/>
              <a:gd name="connsiteX30" fmla="*/ 3232298 w 3264195"/>
              <a:gd name="connsiteY30" fmla="*/ 2137144 h 2626242"/>
              <a:gd name="connsiteX31" fmla="*/ 3264195 w 3264195"/>
              <a:gd name="connsiteY31" fmla="*/ 1605516 h 2626242"/>
              <a:gd name="connsiteX32" fmla="*/ 3264195 w 3264195"/>
              <a:gd name="connsiteY32" fmla="*/ 1201479 h 26262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</a:cxnLst>
            <a:rect l="l" t="t" r="r" b="b"/>
            <a:pathLst>
              <a:path w="3264195" h="2626242">
                <a:moveTo>
                  <a:pt x="3264195" y="1201479"/>
                </a:moveTo>
                <a:lnTo>
                  <a:pt x="3242930" y="723014"/>
                </a:lnTo>
                <a:lnTo>
                  <a:pt x="3094074" y="106325"/>
                </a:lnTo>
                <a:lnTo>
                  <a:pt x="3040912" y="31898"/>
                </a:lnTo>
                <a:lnTo>
                  <a:pt x="2923954" y="0"/>
                </a:lnTo>
                <a:lnTo>
                  <a:pt x="2764465" y="21265"/>
                </a:lnTo>
                <a:lnTo>
                  <a:pt x="2190307" y="74428"/>
                </a:lnTo>
                <a:lnTo>
                  <a:pt x="1765005" y="74428"/>
                </a:lnTo>
                <a:lnTo>
                  <a:pt x="935665" y="85060"/>
                </a:lnTo>
                <a:lnTo>
                  <a:pt x="574158" y="85060"/>
                </a:lnTo>
                <a:lnTo>
                  <a:pt x="350874" y="85060"/>
                </a:lnTo>
                <a:lnTo>
                  <a:pt x="212651" y="127591"/>
                </a:lnTo>
                <a:lnTo>
                  <a:pt x="127591" y="180753"/>
                </a:lnTo>
                <a:lnTo>
                  <a:pt x="53163" y="297711"/>
                </a:lnTo>
                <a:lnTo>
                  <a:pt x="0" y="510363"/>
                </a:lnTo>
                <a:lnTo>
                  <a:pt x="21265" y="723014"/>
                </a:lnTo>
                <a:lnTo>
                  <a:pt x="127591" y="999460"/>
                </a:lnTo>
                <a:lnTo>
                  <a:pt x="669851" y="1244009"/>
                </a:lnTo>
                <a:lnTo>
                  <a:pt x="797442" y="1360967"/>
                </a:lnTo>
                <a:lnTo>
                  <a:pt x="893135" y="1488558"/>
                </a:lnTo>
                <a:lnTo>
                  <a:pt x="914400" y="1775637"/>
                </a:lnTo>
                <a:lnTo>
                  <a:pt x="946298" y="2222205"/>
                </a:lnTo>
                <a:lnTo>
                  <a:pt x="988828" y="2445488"/>
                </a:lnTo>
                <a:lnTo>
                  <a:pt x="1105786" y="2488018"/>
                </a:lnTo>
                <a:lnTo>
                  <a:pt x="1371600" y="2562446"/>
                </a:lnTo>
                <a:lnTo>
                  <a:pt x="1935126" y="2615609"/>
                </a:lnTo>
                <a:lnTo>
                  <a:pt x="2477386" y="2626242"/>
                </a:lnTo>
                <a:lnTo>
                  <a:pt x="2955851" y="2615609"/>
                </a:lnTo>
                <a:lnTo>
                  <a:pt x="3083442" y="2541181"/>
                </a:lnTo>
                <a:lnTo>
                  <a:pt x="3211033" y="2360428"/>
                </a:lnTo>
                <a:lnTo>
                  <a:pt x="3232298" y="2137144"/>
                </a:lnTo>
                <a:lnTo>
                  <a:pt x="3264195" y="1605516"/>
                </a:lnTo>
                <a:lnTo>
                  <a:pt x="3264195" y="1201479"/>
                </a:lnTo>
                <a:close/>
              </a:path>
            </a:pathLst>
          </a:custGeom>
          <a:solidFill>
            <a:srgbClr val="96DCF8">
              <a:alpha val="50196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32105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7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in Flück</dc:creator>
  <cp:lastModifiedBy>FLUECK Martin</cp:lastModifiedBy>
  <cp:revision>108</cp:revision>
  <dcterms:created xsi:type="dcterms:W3CDTF">2025-10-24T17:20:59Z</dcterms:created>
  <dcterms:modified xsi:type="dcterms:W3CDTF">2025-12-18T14:11:43Z</dcterms:modified>
</cp:coreProperties>
</file>